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F0D5EF-017B-4013-BDFE-C85EED7872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CEA6E4D-95B1-4847-B1E5-D2226B1D5D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DC6F25-D260-4E08-9CB1-9CF16AE60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CF7B92-60F2-433B-8825-6A4E446B2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7563C-5527-462B-85CE-7FE51C3B4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0815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00F9A4-5731-4E83-820C-63234399E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2990B6-C5E2-47BD-8513-EC02A8F05A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0C11B-13D2-4D30-98A6-A858964673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07E7D-408A-41C1-9799-74988EE41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1E239D-6FEE-4CC2-A6F7-19532FB49E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227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BAE0ED-9B04-45AE-BEA2-181BD2C485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7DD23C-F272-4333-A63E-701B405642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4EFD93-7EDD-4FDD-B305-AB826A5DA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C00FCC-889B-496D-9BD9-02941B65C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8B050D-ACD5-4133-97D4-F02299454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0050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A805D-51EA-45F2-B62F-4114F52AE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0F6FB3-ECAA-4730-9FD9-E53FD64D9B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68D545-38F2-46C2-BFC2-9F900119E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3F7E67-19E3-4172-92AD-0223D8B6A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B5836A-9FE9-40CE-8738-DFA4247EC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409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91B3A-80A9-451E-BFCB-9550C3AB35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B4061A-6A90-411A-BA4B-377432AB1F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E5FB2-D908-4FC6-B30D-B7909EF2C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C3857C-2349-493B-B1A3-24C5C9762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7963BF-CDE0-4064-BC22-6B6D6A11B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090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606643-7E0B-4E8C-8C7F-E985BAC97D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6DA506-2D8C-490B-83B6-446404CCB6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02027F-22D9-4243-8573-8F96ADE1CE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95E13-C4E4-42A3-BC97-E9AC6194E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1CA44F-B1DF-444F-8AFF-3411DE0C8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7397FB-A688-4FD8-8E02-85D74BAB7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9478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B01860-A93A-468C-9FBE-ECE6B0775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686958-DDB1-4595-94E7-D7C879D2AA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1384F7-A101-4645-990F-32346EBA47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2D416C8-70E1-42CE-8BC0-0C36125092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C52D87-F0D2-400F-9A85-D302616D47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1A909B2-1717-4B42-AF1A-E983C7AD6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E38D44-FBE9-4163-B17F-9777BF553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86DE5C-F7A5-49A0-A605-26EDF0117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083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65E219-46C3-4248-B749-628662CF3C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9823F5-BA1D-4410-BF53-F0079D03A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BAEFA4-F1AF-4D0A-8E54-80B510FC1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49F853-B5E4-4D95-9A2E-F1D904639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7593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649051-F640-4413-B3B0-7EBD27EFD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DA8A8E0-D051-41A0-A54B-0A22C62DF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22A537-37A4-4894-84DC-C7480C3BF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15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242CDA-3818-4620-9A37-57B891917A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45C5D0-111C-4A9B-B865-1195855CA9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7E2994-59A9-498C-B520-689DF69020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DC5528-4B68-4251-872B-1DDA191F89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24B7DB-DCBD-4447-92B6-864E43EC7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709A51-9BCD-4464-82C9-65CC6E2ED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123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0217E5-70E5-45E1-85B2-9832BF1D9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276E83-B658-41D4-9F60-A092BF6E4F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733A56-7609-4369-9D24-D29530752B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EB9DC0-1B7A-4028-9549-F619B6635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B4AD78-A13A-4BED-9F60-96E8C6283F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F22AB0-78ED-4E03-A6EE-B4BD6BECB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966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0CFEF1-12DC-4357-9142-F273BE4A4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216A76-A669-480C-96CC-1DF3BDA83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3688E-08AD-4DDE-881D-205C0E92AA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97FE3-81BA-40B1-B6B9-C55263E99273}" type="datetimeFigureOut">
              <a:rPr lang="en-GB" smtClean="0"/>
              <a:t>14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70F971-9739-4026-9981-2FECC32154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A159A-B898-4B1B-8119-AC1E93E2EAA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B98D7E-BAE3-4C6B-8C32-9167F5C4D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3202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F567D09C-E63C-423E-986C-A8C164CF847F}"/>
              </a:ext>
            </a:extLst>
          </p:cNvPr>
          <p:cNvGrpSpPr/>
          <p:nvPr/>
        </p:nvGrpSpPr>
        <p:grpSpPr>
          <a:xfrm>
            <a:off x="2907898" y="300134"/>
            <a:ext cx="5450633" cy="5038531"/>
            <a:chOff x="2750974" y="304802"/>
            <a:chExt cx="5450633" cy="503853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3A442D3-37DD-4E15-81BB-5611180F9D9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50974" y="304802"/>
              <a:ext cx="5450633" cy="5038531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2BF2992-6253-4055-8536-88EDF41D177B}"/>
                </a:ext>
              </a:extLst>
            </p:cNvPr>
            <p:cNvSpPr txBox="1"/>
            <p:nvPr/>
          </p:nvSpPr>
          <p:spPr>
            <a:xfrm>
              <a:off x="3600838" y="4220544"/>
              <a:ext cx="19874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i="1" dirty="0"/>
                <a:t>Y = 13570 + 32.07 x</a:t>
              </a:r>
              <a:endParaRPr lang="en-GB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1237673" y="5786888"/>
            <a:ext cx="856210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b="1" smtClean="0">
                <a:latin typeface="Times New Roman" panose="02020603050405020304" pitchFamily="18" charset="0"/>
                <a:ea typeface="Calibri" panose="020F0502020204030204" pitchFamily="34" charset="0"/>
              </a:rPr>
              <a:t>S1 Fig</a:t>
            </a:r>
            <a:r>
              <a:rPr lang="en-GB" smtClean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</a:rPr>
              <a:t>Correlation regression analysis of number of protein sequences with molecular weight of proteomes (kDa).</a:t>
            </a:r>
            <a:endParaRPr lang="en-US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8838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25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nta Tapan</dc:creator>
  <cp:lastModifiedBy>HP</cp:lastModifiedBy>
  <cp:revision>22</cp:revision>
  <dcterms:created xsi:type="dcterms:W3CDTF">2021-02-11T11:01:08Z</dcterms:created>
  <dcterms:modified xsi:type="dcterms:W3CDTF">2022-09-14T05:43:15Z</dcterms:modified>
</cp:coreProperties>
</file>